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6" d="100"/>
          <a:sy n="56" d="100"/>
        </p:scale>
        <p:origin x="696" y="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AAF1E6-3D18-455A-A988-8813351A4D8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C63508A-FF7C-498E-904F-E9210B06B7C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4EF6D0-75B6-4692-957B-E12C1AA13F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1E4860-3978-4953-96E0-DF955C60A76F}" type="datetimeFigureOut">
              <a:rPr lang="en-GB" smtClean="0"/>
              <a:t>05/0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D35144-317E-4920-A4C4-6536983411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D5B9F7-86C7-4669-9FBA-010338A2C1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0464A-AF13-45F0-AF1F-A978C96019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66739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5E7FEF-7B22-4D9A-8C3C-74B347FEF8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3198B5F-7744-4667-AB58-811C6D52420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471DEA-314B-4B89-AAFD-335CC4A175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1E4860-3978-4953-96E0-DF955C60A76F}" type="datetimeFigureOut">
              <a:rPr lang="en-GB" smtClean="0"/>
              <a:t>05/0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AAA11D-4633-48C5-AE95-515B096BBA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CB53C2-EC53-4046-9446-DB8ABB7645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0464A-AF13-45F0-AF1F-A978C96019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55665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1F1C559-6CA4-4AA3-931E-FABD1610A4A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B4D0A86-DFA7-4E2B-A2BB-72A95A8E0B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B91D49-9127-487A-B570-473341E1C6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1E4860-3978-4953-96E0-DF955C60A76F}" type="datetimeFigureOut">
              <a:rPr lang="en-GB" smtClean="0"/>
              <a:t>05/0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D84487-E988-4AFB-899A-D849FDD5E7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7F117A-491A-452B-A59F-3F550C3DAD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0464A-AF13-45F0-AF1F-A978C96019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18262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C16A5F-E279-4EAB-BFF9-11EEE54889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25FB5F-2FE5-4D98-A111-27722666620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FACA8B-1D8A-4ADE-908C-E018896825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1E4860-3978-4953-96E0-DF955C60A76F}" type="datetimeFigureOut">
              <a:rPr lang="en-GB" smtClean="0"/>
              <a:t>05/0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7F770E-895C-4B38-AAC2-1C75F07FC5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3ADB7F-F5B7-4DBC-AF41-1097781EF3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0464A-AF13-45F0-AF1F-A978C96019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3617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34DFDF-DB31-41FC-BB5B-E894D863D0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D513B6D-BC47-4AE4-9653-179F41CBE7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C7FE8E-038E-432E-A188-CFF6F6E69A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1E4860-3978-4953-96E0-DF955C60A76F}" type="datetimeFigureOut">
              <a:rPr lang="en-GB" smtClean="0"/>
              <a:t>05/0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0213F2-6624-41E2-91C9-0DC52F01BC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56DBD3-2B2C-4C73-99C6-D80920A21C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0464A-AF13-45F0-AF1F-A978C96019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98776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6D1490-7AAE-4AFD-B37E-9C617FF002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DEAD27B-BBCC-47BB-BAE3-32A962135D2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A162AF9-D58D-4D6D-BBB2-BCB9754861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83107B4-57B2-498D-8BDE-811650572A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1E4860-3978-4953-96E0-DF955C60A76F}" type="datetimeFigureOut">
              <a:rPr lang="en-GB" smtClean="0"/>
              <a:t>05/01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D97FCD9-2FB7-44AB-B59D-8F2FC6E20E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ECB7935-0FDE-4199-BE26-CDC414F602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0464A-AF13-45F0-AF1F-A978C96019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45085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AF19CF-7C9B-41DE-8A42-C52E88F183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A8CA76C-2CF3-48BF-B14E-88308C4738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2D68807-E0A6-41F6-BF55-FE43E7731E9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8D4C5FE-F1A0-49F9-ACC6-0F56C6728C9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CE8847A-4402-42D6-817F-B1A775B7249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E89B3BD-0B8C-4E44-A959-DA212267B5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1E4860-3978-4953-96E0-DF955C60A76F}" type="datetimeFigureOut">
              <a:rPr lang="en-GB" smtClean="0"/>
              <a:t>05/01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B0C18DC-AD0D-4E72-B05C-ED5AD87594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14E79C8-11C0-4768-AD53-88511B377C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0464A-AF13-45F0-AF1F-A978C96019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344301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E67233-8AF2-48C7-A855-4C5C6AFBD0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2E9717B-7AFA-481A-9921-77F60286D1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1E4860-3978-4953-96E0-DF955C60A76F}" type="datetimeFigureOut">
              <a:rPr lang="en-GB" smtClean="0"/>
              <a:t>05/01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A926612-A04F-4E3C-A04B-4BE3AA8787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092D908-01D9-44EE-B958-A4FE888D20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0464A-AF13-45F0-AF1F-A978C96019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94221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4D5293A-6B32-4BAB-B5AC-C9CA2DF9BF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1E4860-3978-4953-96E0-DF955C60A76F}" type="datetimeFigureOut">
              <a:rPr lang="en-GB" smtClean="0"/>
              <a:t>05/01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951FA85-256B-46E0-94C7-9BB7726AEA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1EE4C2D-148C-4621-8E87-23FAA25CE0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0464A-AF13-45F0-AF1F-A978C96019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85496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24EA4B-0399-4EE2-A3AB-C3FCAC9A82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546A930-0748-4A30-A004-264D7E51512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4F57A9D-9772-4977-9B49-5FD78CE2A5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DCA2EE2-8752-46A1-87DD-2122923D25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1E4860-3978-4953-96E0-DF955C60A76F}" type="datetimeFigureOut">
              <a:rPr lang="en-GB" smtClean="0"/>
              <a:t>05/01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6F01189-65FE-453F-9470-D8A0D35F8D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8BE7813-BD23-43F1-9616-6893129A24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0464A-AF13-45F0-AF1F-A978C96019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26666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904566-4A6D-444D-9415-DD3A6F5770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90DC2BF-3AB4-446D-93A1-E598B1049C6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22C5A0C-EE8C-41F2-807F-DD834189E2F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2ECF07F-651A-4449-94AA-7CEC06AB92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1E4860-3978-4953-96E0-DF955C60A76F}" type="datetimeFigureOut">
              <a:rPr lang="en-GB" smtClean="0"/>
              <a:t>05/01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8C08E71-03DC-48AF-949F-EB1E6E92D1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552DE37-BF2B-46F0-985F-764FAB2310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0464A-AF13-45F0-AF1F-A978C96019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44113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F0A9957-9975-4FB7-AD31-75E6BF89C0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8BFC50B-81A0-4543-B12E-AE77083B3B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FE541F-42BF-4909-9291-1DBEB979A84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1E4860-3978-4953-96E0-DF955C60A76F}" type="datetimeFigureOut">
              <a:rPr lang="en-GB" smtClean="0"/>
              <a:t>05/0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03AE39-0325-41F1-9162-00E29BBA481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BEAD59-73B5-43CE-821A-F0A9D6398E9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40464A-AF13-45F0-AF1F-A978C96019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82365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AD11BCA-99BB-45F2-B982-76938694080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69357" y="352916"/>
            <a:ext cx="6853286" cy="500886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CBB72CF5-F288-454F-8068-9E7D753011A0}"/>
              </a:ext>
            </a:extLst>
          </p:cNvPr>
          <p:cNvSpPr txBox="1"/>
          <p:nvPr/>
        </p:nvSpPr>
        <p:spPr>
          <a:xfrm>
            <a:off x="1325462" y="5581754"/>
            <a:ext cx="10578516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GB" sz="1800" b="0" i="0" u="none" strike="noStrike" baseline="0" dirty="0">
                <a:latin typeface="PalatinoLinotype-Roman"/>
              </a:rPr>
              <a:t>Figure S3: Permutation test statistics over 100 iterations with selected metabolites for ICU</a:t>
            </a:r>
          </a:p>
          <a:p>
            <a:pPr algn="l"/>
            <a:r>
              <a:rPr lang="en-GB" sz="1800" b="0" i="0" u="none" strike="noStrike" baseline="0" dirty="0">
                <a:latin typeface="PalatinoLinotype-Roman"/>
              </a:rPr>
              <a:t>LOS &gt; 10 vs. </a:t>
            </a:r>
            <a:r>
              <a:rPr lang="en-GB" sz="1800" b="0" i="0" u="none" strike="noStrike" baseline="0">
                <a:latin typeface="PalatinoLinotype-Roman"/>
              </a:rPr>
              <a:t>&lt;10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8172963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2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PalatinoLinotype-Roman</vt:lpstr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imesh Acharjee (Cancer and Genomic Sciences)</dc:creator>
  <cp:lastModifiedBy>MDPI</cp:lastModifiedBy>
  <cp:revision>2</cp:revision>
  <dcterms:created xsi:type="dcterms:W3CDTF">2022-01-04T11:07:29Z</dcterms:created>
  <dcterms:modified xsi:type="dcterms:W3CDTF">2022-01-05T05:49:23Z</dcterms:modified>
</cp:coreProperties>
</file>